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8"/>
  </p:notesMasterIdLst>
  <p:sldIdLst>
    <p:sldId id="281" r:id="rId2"/>
    <p:sldId id="275" r:id="rId3"/>
    <p:sldId id="276" r:id="rId4"/>
    <p:sldId id="278" r:id="rId5"/>
    <p:sldId id="279" r:id="rId6"/>
    <p:sldId id="280" r:id="rId7"/>
  </p:sldIdLst>
  <p:sldSz cx="12192000" cy="68580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4" d="100"/>
          <a:sy n="104" d="100"/>
        </p:scale>
        <p:origin x="-256" y="-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688" y="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FBA8B1-F704-47CD-A222-401A37400849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698500"/>
            <a:ext cx="62007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9600"/>
            <a:ext cx="5616575" cy="4187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20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688" y="883920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C2DC94-C6B2-4C4C-BD9F-833D50ED5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56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2374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9291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6000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23125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5719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C2DC94-C6B2-4C4C-BD9F-833D50ED564A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4593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61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570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36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540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8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621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114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995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025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938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422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B9C9C-A06F-4F6C-9C65-1D690823A109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D56C2-0754-468A-9481-3D9882EF9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140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46200" y="44873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1693333" y="1066800"/>
            <a:ext cx="8881534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le S4: Quantitative trait loci (shown as 95% Bayes credible intervals) for growth-related traits in the non-transgenic and transgenic </a:t>
            </a:r>
            <a:r>
              <a:rPr lang="en-US" b="1" dirty="0" err="1"/>
              <a:t>coho</a:t>
            </a:r>
            <a:r>
              <a:rPr lang="en-US" b="1" dirty="0"/>
              <a:t> salmon. </a:t>
            </a:r>
            <a:endParaRPr lang="en-US" b="1" dirty="0" smtClean="0"/>
          </a:p>
          <a:p>
            <a:endParaRPr lang="en-US" b="1" dirty="0"/>
          </a:p>
          <a:p>
            <a:r>
              <a:rPr lang="en-US" dirty="0" smtClean="0"/>
              <a:t>Only </a:t>
            </a:r>
            <a:r>
              <a:rPr lang="en-US" dirty="0"/>
              <a:t>linkage groups with significant QTL (detected </a:t>
            </a:r>
            <a:r>
              <a:rPr lang="en-US" dirty="0" smtClean="0"/>
              <a:t>using</a:t>
            </a:r>
            <a:r>
              <a:rPr lang="en-US" dirty="0" smtClean="0"/>
              <a:t> </a:t>
            </a:r>
            <a:r>
              <a:rPr lang="en-US" dirty="0"/>
              <a:t>either maternal or </a:t>
            </a:r>
            <a:r>
              <a:rPr lang="en-US" dirty="0" smtClean="0"/>
              <a:t>paternal meiosis) </a:t>
            </a:r>
            <a:r>
              <a:rPr lang="en-US" dirty="0"/>
              <a:t>are shown, and linkage groups are named accordingly to the previously published map (Kodama </a:t>
            </a:r>
            <a:r>
              <a:rPr lang="en-US" i="1" dirty="0"/>
              <a:t>et al. </a:t>
            </a:r>
            <a:r>
              <a:rPr lang="en-US" dirty="0"/>
              <a:t>2014). The marker associated with each QTL is shown by a horizontal bar. QTL for lengths, weights and daily growth coefficients are shown in green, blue and pink, respectively. A parent (dam or sire) in which the corresponding QTL were detected are shown in parentheses.</a:t>
            </a:r>
            <a:r>
              <a:rPr lang="en-US" b="1" dirty="0"/>
              <a:t> </a:t>
            </a:r>
            <a:r>
              <a:rPr lang="en-US" dirty="0"/>
              <a:t>QTL detected in the non-transgenic and transgenic fish are shown as top and bottom row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327476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924300" y="335280"/>
            <a:ext cx="6629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816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3152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398814" y="257320"/>
            <a:ext cx="8294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01                          03                                                04</a:t>
            </a:r>
            <a:endParaRPr lang="en-US" sz="1400" dirty="0"/>
          </a:p>
        </p:txBody>
      </p:sp>
      <p:pic>
        <p:nvPicPr>
          <p:cNvPr id="13" name="Content Placeholder 12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19" r="8527" b="12934"/>
          <a:stretch/>
        </p:blipFill>
        <p:spPr>
          <a:xfrm>
            <a:off x="3032357" y="492707"/>
            <a:ext cx="5713227" cy="3004457"/>
          </a:xfrm>
        </p:spPr>
      </p:pic>
      <p:pic>
        <p:nvPicPr>
          <p:cNvPr id="14" name="Content Placeholder 1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95" b="12307"/>
          <a:stretch/>
        </p:blipFill>
        <p:spPr>
          <a:xfrm>
            <a:off x="3038378" y="3471054"/>
            <a:ext cx="6245762" cy="3050177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902825" y="1724628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transgenic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214377" y="4719694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r>
              <a:rPr lang="en-US" dirty="0" smtClean="0"/>
              <a:t>ransgenic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3848100" y="483870"/>
            <a:ext cx="73914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5137150" y="445082"/>
            <a:ext cx="151130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7296150" y="450744"/>
            <a:ext cx="151130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02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924300" y="335280"/>
            <a:ext cx="6629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816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3152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02825" y="1724628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transgeni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214377" y="4719694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r>
              <a:rPr lang="en-US" dirty="0" smtClean="0"/>
              <a:t>ransgeni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395257" y="240170"/>
            <a:ext cx="8294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07           11                                         15</a:t>
            </a:r>
            <a:endParaRPr lang="en-US" sz="1400" dirty="0"/>
          </a:p>
        </p:txBody>
      </p:sp>
      <p:sp>
        <p:nvSpPr>
          <p:cNvPr id="17" name="Rectangle 16"/>
          <p:cNvSpPr/>
          <p:nvPr/>
        </p:nvSpPr>
        <p:spPr>
          <a:xfrm>
            <a:off x="4303776" y="3691795"/>
            <a:ext cx="145084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6076772" y="3662312"/>
            <a:ext cx="2414956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679406" y="3754942"/>
            <a:ext cx="44500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325" r="12179" b="12028"/>
          <a:stretch/>
        </p:blipFill>
        <p:spPr>
          <a:xfrm>
            <a:off x="3044964" y="489851"/>
            <a:ext cx="5485083" cy="3030583"/>
          </a:xfrm>
        </p:spPr>
      </p:pic>
      <p:pic>
        <p:nvPicPr>
          <p:cNvPr id="20" name="Content Placeholder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24" r="12737" b="11779"/>
          <a:stretch/>
        </p:blipFill>
        <p:spPr>
          <a:xfrm>
            <a:off x="3041480" y="3509846"/>
            <a:ext cx="5450248" cy="3050177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6076772" y="3509846"/>
            <a:ext cx="2521128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/>
          <p:cNvSpPr/>
          <p:nvPr/>
        </p:nvSpPr>
        <p:spPr>
          <a:xfrm>
            <a:off x="4268470" y="3527192"/>
            <a:ext cx="1510834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/>
          <p:cNvSpPr/>
          <p:nvPr/>
        </p:nvSpPr>
        <p:spPr>
          <a:xfrm>
            <a:off x="3679406" y="3539463"/>
            <a:ext cx="30988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96763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924300" y="335280"/>
            <a:ext cx="6629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816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3152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02825" y="1724628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transgenic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4303776" y="3691795"/>
            <a:ext cx="145084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6076772" y="3662312"/>
            <a:ext cx="2414956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679406" y="3754942"/>
            <a:ext cx="44500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7315200" y="395454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5188613" y="3735165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672497" y="378920"/>
            <a:ext cx="583273" cy="3137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4614201" y="437349"/>
            <a:ext cx="292183" cy="2469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84" r="2977" b="12868"/>
          <a:stretch/>
        </p:blipFill>
        <p:spPr>
          <a:xfrm>
            <a:off x="3046848" y="365508"/>
            <a:ext cx="6059848" cy="3043646"/>
          </a:xfrm>
        </p:spPr>
      </p:pic>
      <p:pic>
        <p:nvPicPr>
          <p:cNvPr id="24" name="Content Placeholder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84" r="2175" b="12767"/>
          <a:stretch/>
        </p:blipFill>
        <p:spPr>
          <a:xfrm>
            <a:off x="3048052" y="3396343"/>
            <a:ext cx="6109922" cy="3135085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1214377" y="4719694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r>
              <a:rPr lang="en-US" dirty="0" smtClean="0"/>
              <a:t>ransgenic</a:t>
            </a:r>
            <a:endParaRPr lang="en-US" dirty="0"/>
          </a:p>
        </p:txBody>
      </p:sp>
      <p:sp>
        <p:nvSpPr>
          <p:cNvPr id="28" name="Rectangle 27"/>
          <p:cNvSpPr/>
          <p:nvPr/>
        </p:nvSpPr>
        <p:spPr>
          <a:xfrm>
            <a:off x="7337336" y="369153"/>
            <a:ext cx="2521128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5188613" y="3439283"/>
            <a:ext cx="182880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4587240" y="335279"/>
            <a:ext cx="354937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3679406" y="389889"/>
            <a:ext cx="62437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/>
          <p:cNvSpPr txBox="1"/>
          <p:nvPr/>
        </p:nvSpPr>
        <p:spPr>
          <a:xfrm>
            <a:off x="3401788" y="181391"/>
            <a:ext cx="8294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6                   19           20                                                2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435594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924300" y="335280"/>
            <a:ext cx="6629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816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3152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02825" y="1724628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transgeni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85777" y="4850322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r>
              <a:rPr lang="en-US" dirty="0" smtClean="0"/>
              <a:t>ransgenic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4303776" y="3691795"/>
            <a:ext cx="145084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679406" y="3754942"/>
            <a:ext cx="44500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7315200" y="395454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5188613" y="3735165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672497" y="378920"/>
            <a:ext cx="583273" cy="3137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4614201" y="437349"/>
            <a:ext cx="292183" cy="2469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438000" y="192966"/>
            <a:ext cx="8294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5                                         27</a:t>
            </a:r>
            <a:endParaRPr lang="en-US" sz="1400" dirty="0"/>
          </a:p>
        </p:txBody>
      </p:sp>
      <p:sp>
        <p:nvSpPr>
          <p:cNvPr id="25" name="Rectangle 24"/>
          <p:cNvSpPr/>
          <p:nvPr/>
        </p:nvSpPr>
        <p:spPr>
          <a:xfrm>
            <a:off x="3699801" y="3672017"/>
            <a:ext cx="1488812" cy="2803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5528601" y="3662312"/>
            <a:ext cx="1488812" cy="2803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813" r="55533" b="13290"/>
          <a:stretch/>
        </p:blipFill>
        <p:spPr>
          <a:xfrm>
            <a:off x="3091166" y="478937"/>
            <a:ext cx="2777329" cy="2997927"/>
          </a:xfrm>
        </p:spPr>
      </p:pic>
      <p:pic>
        <p:nvPicPr>
          <p:cNvPr id="27" name="Content Placeholder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87779" y="3460226"/>
            <a:ext cx="2752286" cy="3063240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3730536" y="3423552"/>
            <a:ext cx="1451064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5528601" y="3419554"/>
            <a:ext cx="420840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8726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924300" y="335280"/>
            <a:ext cx="6629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816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315200" y="335280"/>
            <a:ext cx="1539240" cy="29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02825" y="1724628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transgeni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85777" y="4850322"/>
            <a:ext cx="189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r>
              <a:rPr lang="en-US" dirty="0" smtClean="0"/>
              <a:t>ransgenic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4303776" y="3691795"/>
            <a:ext cx="145084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6076772" y="3662312"/>
            <a:ext cx="2414956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679406" y="3754942"/>
            <a:ext cx="445008" cy="1974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7315200" y="395454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5188613" y="3735165"/>
            <a:ext cx="1828800" cy="237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672497" y="378920"/>
            <a:ext cx="583273" cy="3137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4614201" y="437349"/>
            <a:ext cx="292183" cy="2469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438000" y="283460"/>
            <a:ext cx="8294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0</a:t>
            </a:r>
            <a:endParaRPr lang="en-US" sz="1400" dirty="0"/>
          </a:p>
        </p:txBody>
      </p:sp>
      <p:sp>
        <p:nvSpPr>
          <p:cNvPr id="25" name="Rectangle 24"/>
          <p:cNvSpPr/>
          <p:nvPr/>
        </p:nvSpPr>
        <p:spPr>
          <a:xfrm>
            <a:off x="3699801" y="3672017"/>
            <a:ext cx="1488812" cy="2803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5528601" y="3662312"/>
            <a:ext cx="1488812" cy="2803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944292" y="399624"/>
            <a:ext cx="3949642" cy="3605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86" r="23024" b="13146"/>
          <a:stretch/>
        </p:blipFill>
        <p:spPr>
          <a:xfrm>
            <a:off x="3086185" y="535777"/>
            <a:ext cx="4807749" cy="3014134"/>
          </a:xfrm>
        </p:spPr>
      </p:pic>
      <p:pic>
        <p:nvPicPr>
          <p:cNvPr id="24" name="Content Placeholder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79" r="27633" b="13340"/>
          <a:stretch/>
        </p:blipFill>
        <p:spPr>
          <a:xfrm>
            <a:off x="3088821" y="3536388"/>
            <a:ext cx="4519882" cy="2997200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3964132" y="483870"/>
            <a:ext cx="3929801" cy="240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8149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</Words>
  <Application>Microsoft Office PowerPoint</Application>
  <PresentationFormat>Custom</PresentationFormat>
  <Paragraphs>24</Paragraphs>
  <Slides>6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8-07-24T02:25:14Z</dcterms:created>
  <dcterms:modified xsi:type="dcterms:W3CDTF">2018-08-01T13:16:24Z</dcterms:modified>
</cp:coreProperties>
</file>